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 varScale="1">
        <p:scale>
          <a:sx n="64" d="100"/>
          <a:sy n="64" d="100"/>
        </p:scale>
        <p:origin x="40" y="1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038714709555348E-2"/>
          <c:y val="2.7574649122418891E-2"/>
          <c:w val="0.9464717548653363"/>
          <c:h val="0.819445612052326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5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LDL&lt;70mg/dL</c:v>
                </c:pt>
                <c:pt idx="1">
                  <c:v>LDL≥50% Reduction</c:v>
                </c:pt>
                <c:pt idx="2">
                  <c:v>LDL&lt;70mg/dL and LDL≥50% Reduction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35.71</c:v>
                </c:pt>
                <c:pt idx="1">
                  <c:v>52.86</c:v>
                </c:pt>
                <c:pt idx="2">
                  <c:v>31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3D-48E9-9E59-0DE5BDCBD776}"/>
            </c:ext>
          </c:extLst>
        </c:ser>
        <c:ser>
          <c:idx val="2"/>
          <c:order val="1"/>
          <c:tx>
            <c:strRef>
              <c:f>Sheet1!$D$1</c:f>
              <c:strCache>
                <c:ptCount val="1"/>
                <c:pt idx="0">
                  <c:v>E</c:v>
                </c:pt>
              </c:strCache>
            </c:strRef>
          </c:tx>
          <c:spPr>
            <a:pattFill prst="wdDnDiag">
              <a:fgClr>
                <a:schemeClr val="accent3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LDL&lt;70mg/dL</c:v>
                </c:pt>
                <c:pt idx="1">
                  <c:v>LDL≥50% Reduction</c:v>
                </c:pt>
                <c:pt idx="2">
                  <c:v>LDL&lt;70mg/dL and LDL≥50% Reduction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8.11</c:v>
                </c:pt>
                <c:pt idx="1">
                  <c:v>8.11</c:v>
                </c:pt>
                <c:pt idx="2">
                  <c:v>8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3D-48E9-9E59-0DE5BDCBD776}"/>
            </c:ext>
          </c:extLst>
        </c:ser>
        <c:ser>
          <c:idx val="1"/>
          <c:order val="2"/>
          <c:tx>
            <c:strRef>
              <c:f>Sheet1!$C$1</c:f>
              <c:strCache>
                <c:ptCount val="1"/>
                <c:pt idx="0">
                  <c:v>A5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 w="12700"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LDL&lt;70mg/dL</c:v>
                </c:pt>
                <c:pt idx="1">
                  <c:v>LDL≥50% Reduction</c:v>
                </c:pt>
                <c:pt idx="2">
                  <c:v>LDL&lt;70mg/dL and LDL≥50% Reduction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13.89</c:v>
                </c:pt>
                <c:pt idx="1">
                  <c:v>16.670000000000002</c:v>
                </c:pt>
                <c:pt idx="2">
                  <c:v>9.72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3D-48E9-9E59-0DE5BDCBD776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A10</c:v>
                </c:pt>
              </c:strCache>
            </c:strRef>
          </c:tx>
          <c:spPr>
            <a:pattFill prst="lgCheck">
              <a:fgClr>
                <a:schemeClr val="accent4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LDL&lt;70mg/dL</c:v>
                </c:pt>
                <c:pt idx="1">
                  <c:v>LDL≥50% Reduction</c:v>
                </c:pt>
                <c:pt idx="2">
                  <c:v>LDL&lt;70mg/dL and LDL≥50% Reduction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15.94</c:v>
                </c:pt>
                <c:pt idx="1">
                  <c:v>13.04</c:v>
                </c:pt>
                <c:pt idx="2">
                  <c:v>7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B3D-48E9-9E59-0DE5BDCBD77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99"/>
        <c:axId val="1453807711"/>
        <c:axId val="1453808543"/>
      </c:barChart>
      <c:catAx>
        <c:axId val="1453807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453808543"/>
        <c:crosses val="autoZero"/>
        <c:auto val="1"/>
        <c:lblAlgn val="ctr"/>
        <c:lblOffset val="100"/>
        <c:noMultiLvlLbl val="0"/>
      </c:catAx>
      <c:valAx>
        <c:axId val="1453808543"/>
        <c:scaling>
          <c:orientation val="minMax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4538077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/>
      </a:pPr>
      <a:endParaRPr lang="ko-KR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762</cdr:x>
      <cdr:y>0.13654</cdr:y>
    </cdr:from>
    <cdr:to>
      <cdr:x>0.44762</cdr:x>
      <cdr:y>0.17423</cdr:y>
    </cdr:to>
    <cdr:cxnSp macro="">
      <cdr:nvCxnSpPr>
        <cdr:cNvPr id="6" name="직선 연결선 5">
          <a:extLst xmlns:a="http://schemas.openxmlformats.org/drawingml/2006/main">
            <a:ext uri="{FF2B5EF4-FFF2-40B4-BE49-F238E27FC236}">
              <a16:creationId xmlns:a16="http://schemas.microsoft.com/office/drawing/2014/main" id="{3A085F68-63D5-90C4-BEA6-B62427DE85DC}"/>
            </a:ext>
          </a:extLst>
        </cdr:cNvPr>
        <cdr:cNvCxnSpPr/>
      </cdr:nvCxnSpPr>
      <cdr:spPr>
        <a:xfrm xmlns:a="http://schemas.openxmlformats.org/drawingml/2006/main">
          <a:off x="4325936" y="648031"/>
          <a:ext cx="0" cy="178905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66</cdr:x>
      <cdr:y>0.13654</cdr:y>
    </cdr:from>
    <cdr:to>
      <cdr:x>0.4766</cdr:x>
      <cdr:y>0.58575</cdr:y>
    </cdr:to>
    <cdr:cxnSp macro="">
      <cdr:nvCxnSpPr>
        <cdr:cNvPr id="8" name="직선 연결선 7">
          <a:extLst xmlns:a="http://schemas.openxmlformats.org/drawingml/2006/main">
            <a:ext uri="{FF2B5EF4-FFF2-40B4-BE49-F238E27FC236}">
              <a16:creationId xmlns:a16="http://schemas.microsoft.com/office/drawing/2014/main" id="{855E2CE9-5A05-6B72-569B-7DBF864A6E9F}"/>
            </a:ext>
          </a:extLst>
        </cdr:cNvPr>
        <cdr:cNvCxnSpPr/>
      </cdr:nvCxnSpPr>
      <cdr:spPr>
        <a:xfrm xmlns:a="http://schemas.openxmlformats.org/drawingml/2006/main">
          <a:off x="4606027" y="648031"/>
          <a:ext cx="0" cy="213204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9924</cdr:x>
      <cdr:y>0.26526</cdr:y>
    </cdr:from>
    <cdr:to>
      <cdr:x>0.86532</cdr:x>
      <cdr:y>0.31065</cdr:y>
    </cdr:to>
    <cdr:sp macro="" textlink="">
      <cdr:nvSpPr>
        <cdr:cNvPr id="14" name="TextBox 46">
          <a:extLst xmlns:a="http://schemas.openxmlformats.org/drawingml/2006/main">
            <a:ext uri="{FF2B5EF4-FFF2-40B4-BE49-F238E27FC236}">
              <a16:creationId xmlns:a16="http://schemas.microsoft.com/office/drawing/2014/main" id="{6EA43285-D287-F68B-79FE-C3099D92F309}"/>
            </a:ext>
          </a:extLst>
        </cdr:cNvPr>
        <cdr:cNvSpPr txBox="1"/>
      </cdr:nvSpPr>
      <cdr:spPr>
        <a:xfrm xmlns:a="http://schemas.openxmlformats.org/drawingml/2006/main">
          <a:off x="7724173" y="1258955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0003</a:t>
          </a:r>
        </a:p>
      </cdr:txBody>
    </cdr:sp>
  </cdr:relSizeAnchor>
  <cdr:relSizeAnchor xmlns:cdr="http://schemas.openxmlformats.org/drawingml/2006/chartDrawing">
    <cdr:from>
      <cdr:x>0.75356</cdr:x>
      <cdr:y>0.33489</cdr:y>
    </cdr:from>
    <cdr:to>
      <cdr:x>0.81964</cdr:x>
      <cdr:y>0.38028</cdr:y>
    </cdr:to>
    <cdr:sp macro="" textlink="">
      <cdr:nvSpPr>
        <cdr:cNvPr id="15" name="TextBox 46">
          <a:extLst xmlns:a="http://schemas.openxmlformats.org/drawingml/2006/main">
            <a:ext uri="{FF2B5EF4-FFF2-40B4-BE49-F238E27FC236}">
              <a16:creationId xmlns:a16="http://schemas.microsoft.com/office/drawing/2014/main" id="{A7275F24-9D50-F347-A0CF-0222C51C0C66}"/>
            </a:ext>
          </a:extLst>
        </cdr:cNvPr>
        <cdr:cNvSpPr txBox="1"/>
      </cdr:nvSpPr>
      <cdr:spPr>
        <a:xfrm xmlns:a="http://schemas.openxmlformats.org/drawingml/2006/main">
          <a:off x="7282654" y="1589446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0004</a:t>
          </a:r>
        </a:p>
      </cdr:txBody>
    </cdr:sp>
  </cdr:relSizeAnchor>
  <cdr:relSizeAnchor xmlns:cdr="http://schemas.openxmlformats.org/drawingml/2006/chartDrawing">
    <cdr:from>
      <cdr:x>0.78366</cdr:x>
      <cdr:y>0.3029</cdr:y>
    </cdr:from>
    <cdr:to>
      <cdr:x>0.84974</cdr:x>
      <cdr:y>0.34829</cdr:y>
    </cdr:to>
    <cdr:sp macro="" textlink="">
      <cdr:nvSpPr>
        <cdr:cNvPr id="16" name="TextBox 46">
          <a:extLst xmlns:a="http://schemas.openxmlformats.org/drawingml/2006/main">
            <a:ext uri="{FF2B5EF4-FFF2-40B4-BE49-F238E27FC236}">
              <a16:creationId xmlns:a16="http://schemas.microsoft.com/office/drawing/2014/main" id="{04AC3CFF-83CE-AE78-96EC-EAC7A851F166}"/>
            </a:ext>
          </a:extLst>
        </cdr:cNvPr>
        <cdr:cNvSpPr txBox="1"/>
      </cdr:nvSpPr>
      <cdr:spPr>
        <a:xfrm xmlns:a="http://schemas.openxmlformats.org/drawingml/2006/main">
          <a:off x="7573571" y="1437600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0013</a:t>
          </a:r>
        </a:p>
      </cdr:txBody>
    </cdr:sp>
  </cdr:relSizeAnchor>
  <cdr:relSizeAnchor xmlns:cdr="http://schemas.openxmlformats.org/drawingml/2006/chartDrawing">
    <cdr:from>
      <cdr:x>0.80023</cdr:x>
      <cdr:y>0.48454</cdr:y>
    </cdr:from>
    <cdr:to>
      <cdr:x>0.86631</cdr:x>
      <cdr:y>0.52994</cdr:y>
    </cdr:to>
    <cdr:sp macro="" textlink="">
      <cdr:nvSpPr>
        <cdr:cNvPr id="17" name="TextBox 46">
          <a:extLst xmlns:a="http://schemas.openxmlformats.org/drawingml/2006/main">
            <a:ext uri="{FF2B5EF4-FFF2-40B4-BE49-F238E27FC236}">
              <a16:creationId xmlns:a16="http://schemas.microsoft.com/office/drawing/2014/main" id="{8D9B7945-66A9-EBD7-7AAD-84D24D72B822}"/>
            </a:ext>
          </a:extLst>
        </cdr:cNvPr>
        <cdr:cNvSpPr txBox="1"/>
      </cdr:nvSpPr>
      <cdr:spPr>
        <a:xfrm xmlns:a="http://schemas.openxmlformats.org/drawingml/2006/main">
          <a:off x="7733698" y="2299725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7321</a:t>
          </a:r>
        </a:p>
      </cdr:txBody>
    </cdr:sp>
  </cdr:relSizeAnchor>
  <cdr:relSizeAnchor xmlns:cdr="http://schemas.openxmlformats.org/drawingml/2006/chartDrawing">
    <cdr:from>
      <cdr:x>0.48262</cdr:x>
      <cdr:y>0.39502</cdr:y>
    </cdr:from>
    <cdr:to>
      <cdr:x>0.5487</cdr:x>
      <cdr:y>0.44041</cdr:y>
    </cdr:to>
    <cdr:sp macro="" textlink="">
      <cdr:nvSpPr>
        <cdr:cNvPr id="18" name="TextBox 46">
          <a:extLst xmlns:a="http://schemas.openxmlformats.org/drawingml/2006/main">
            <a:ext uri="{FF2B5EF4-FFF2-40B4-BE49-F238E27FC236}">
              <a16:creationId xmlns:a16="http://schemas.microsoft.com/office/drawing/2014/main" id="{A1EFA14C-8B69-C44D-8877-D8AA3EB016A1}"/>
            </a:ext>
          </a:extLst>
        </cdr:cNvPr>
        <cdr:cNvSpPr txBox="1"/>
      </cdr:nvSpPr>
      <cdr:spPr>
        <a:xfrm xmlns:a="http://schemas.openxmlformats.org/drawingml/2006/main">
          <a:off x="4664215" y="1874837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1158</a:t>
          </a:r>
        </a:p>
      </cdr:txBody>
    </cdr:sp>
  </cdr:relSizeAnchor>
  <cdr:relSizeAnchor xmlns:cdr="http://schemas.openxmlformats.org/drawingml/2006/chartDrawing">
    <cdr:from>
      <cdr:x>0.4766</cdr:x>
      <cdr:y>0.02616</cdr:y>
    </cdr:from>
    <cdr:to>
      <cdr:x>0.54268</cdr:x>
      <cdr:y>0.07156</cdr:y>
    </cdr:to>
    <cdr:sp macro="" textlink="">
      <cdr:nvSpPr>
        <cdr:cNvPr id="19" name="TextBox 46">
          <a:extLst xmlns:a="http://schemas.openxmlformats.org/drawingml/2006/main">
            <a:ext uri="{FF2B5EF4-FFF2-40B4-BE49-F238E27FC236}">
              <a16:creationId xmlns:a16="http://schemas.microsoft.com/office/drawing/2014/main" id="{F1C68A7A-C86E-1556-AB4E-E2E527134A73}"/>
            </a:ext>
          </a:extLst>
        </cdr:cNvPr>
        <cdr:cNvSpPr txBox="1"/>
      </cdr:nvSpPr>
      <cdr:spPr>
        <a:xfrm xmlns:a="http://schemas.openxmlformats.org/drawingml/2006/main">
          <a:off x="4606027" y="124182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&lt;0.0001</a:t>
          </a:r>
        </a:p>
      </cdr:txBody>
    </cdr:sp>
  </cdr:relSizeAnchor>
  <cdr:relSizeAnchor xmlns:cdr="http://schemas.openxmlformats.org/drawingml/2006/chartDrawing">
    <cdr:from>
      <cdr:x>0.45682</cdr:x>
      <cdr:y>0.06422</cdr:y>
    </cdr:from>
    <cdr:to>
      <cdr:x>0.5229</cdr:x>
      <cdr:y>0.10962</cdr:y>
    </cdr:to>
    <cdr:sp macro="" textlink="">
      <cdr:nvSpPr>
        <cdr:cNvPr id="20" name="TextBox 46">
          <a:extLst xmlns:a="http://schemas.openxmlformats.org/drawingml/2006/main">
            <a:ext uri="{FF2B5EF4-FFF2-40B4-BE49-F238E27FC236}">
              <a16:creationId xmlns:a16="http://schemas.microsoft.com/office/drawing/2014/main" id="{D798B2D1-073D-3CDA-A435-DEB715E79E16}"/>
            </a:ext>
          </a:extLst>
        </cdr:cNvPr>
        <cdr:cNvSpPr txBox="1"/>
      </cdr:nvSpPr>
      <cdr:spPr>
        <a:xfrm xmlns:a="http://schemas.openxmlformats.org/drawingml/2006/main">
          <a:off x="4414885" y="304812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&lt;0.0001</a:t>
          </a:r>
        </a:p>
      </cdr:txBody>
    </cdr:sp>
  </cdr:relSizeAnchor>
  <cdr:relSizeAnchor xmlns:cdr="http://schemas.openxmlformats.org/drawingml/2006/chartDrawing">
    <cdr:from>
      <cdr:x>0.14171</cdr:x>
      <cdr:y>0.22617</cdr:y>
    </cdr:from>
    <cdr:to>
      <cdr:x>0.20779</cdr:x>
      <cdr:y>0.27156</cdr:y>
    </cdr:to>
    <cdr:sp macro="" textlink="">
      <cdr:nvSpPr>
        <cdr:cNvPr id="21" name="TextBox 46">
          <a:extLst xmlns:a="http://schemas.openxmlformats.org/drawingml/2006/main">
            <a:ext uri="{FF2B5EF4-FFF2-40B4-BE49-F238E27FC236}">
              <a16:creationId xmlns:a16="http://schemas.microsoft.com/office/drawing/2014/main" id="{D798B2D1-073D-3CDA-A435-DEB715E79E16}"/>
            </a:ext>
          </a:extLst>
        </cdr:cNvPr>
        <cdr:cNvSpPr txBox="1"/>
      </cdr:nvSpPr>
      <cdr:spPr>
        <a:xfrm xmlns:a="http://schemas.openxmlformats.org/drawingml/2006/main">
          <a:off x="1369533" y="1073441"/>
          <a:ext cx="638620" cy="21542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800" dirty="0"/>
            <a:t>   0.0026</a:t>
          </a:r>
          <a:endParaRPr lang="en-US" sz="800" dirty="0"/>
        </a:p>
      </cdr:txBody>
    </cdr:sp>
  </cdr:relSizeAnchor>
  <cdr:relSizeAnchor xmlns:cdr="http://schemas.openxmlformats.org/drawingml/2006/chartDrawing">
    <cdr:from>
      <cdr:x>0.15143</cdr:x>
      <cdr:y>0.17321</cdr:y>
    </cdr:from>
    <cdr:to>
      <cdr:x>0.21751</cdr:x>
      <cdr:y>0.2186</cdr:y>
    </cdr:to>
    <cdr:sp macro="" textlink="">
      <cdr:nvSpPr>
        <cdr:cNvPr id="22" name="TextBox 46">
          <a:extLst xmlns:a="http://schemas.openxmlformats.org/drawingml/2006/main">
            <a:ext uri="{FF2B5EF4-FFF2-40B4-BE49-F238E27FC236}">
              <a16:creationId xmlns:a16="http://schemas.microsoft.com/office/drawing/2014/main" id="{1F52E32A-F117-80D9-2411-073CA6003411}"/>
            </a:ext>
          </a:extLst>
        </cdr:cNvPr>
        <cdr:cNvSpPr txBox="1"/>
      </cdr:nvSpPr>
      <cdr:spPr>
        <a:xfrm xmlns:a="http://schemas.openxmlformats.org/drawingml/2006/main">
          <a:off x="1463467" y="822067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0078</a:t>
          </a:r>
        </a:p>
      </cdr:txBody>
    </cdr:sp>
  </cdr:relSizeAnchor>
  <cdr:relSizeAnchor xmlns:cdr="http://schemas.openxmlformats.org/drawingml/2006/chartDrawing">
    <cdr:from>
      <cdr:x>0.43363</cdr:x>
      <cdr:y>0.10369</cdr:y>
    </cdr:from>
    <cdr:to>
      <cdr:x>0.49971</cdr:x>
      <cdr:y>0.14909</cdr:y>
    </cdr:to>
    <cdr:sp macro="" textlink="">
      <cdr:nvSpPr>
        <cdr:cNvPr id="23" name="TextBox 46">
          <a:extLst xmlns:a="http://schemas.openxmlformats.org/drawingml/2006/main">
            <a:ext uri="{FF2B5EF4-FFF2-40B4-BE49-F238E27FC236}">
              <a16:creationId xmlns:a16="http://schemas.microsoft.com/office/drawing/2014/main" id="{1F52E32A-F117-80D9-2411-073CA6003411}"/>
            </a:ext>
          </a:extLst>
        </cdr:cNvPr>
        <cdr:cNvSpPr txBox="1"/>
      </cdr:nvSpPr>
      <cdr:spPr>
        <a:xfrm xmlns:a="http://schemas.openxmlformats.org/drawingml/2006/main">
          <a:off x="4190763" y="492150"/>
          <a:ext cx="63859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&lt;0.0001</a:t>
          </a:r>
        </a:p>
      </cdr:txBody>
    </cdr:sp>
  </cdr:relSizeAnchor>
  <cdr:relSizeAnchor xmlns:cdr="http://schemas.openxmlformats.org/drawingml/2006/chartDrawing">
    <cdr:from>
      <cdr:x>0.12196</cdr:x>
      <cdr:y>0.26775</cdr:y>
    </cdr:from>
    <cdr:to>
      <cdr:x>0.18804</cdr:x>
      <cdr:y>0.31314</cdr:y>
    </cdr:to>
    <cdr:sp macro="" textlink="">
      <cdr:nvSpPr>
        <cdr:cNvPr id="24" name="TextBox 46">
          <a:extLst xmlns:a="http://schemas.openxmlformats.org/drawingml/2006/main">
            <a:ext uri="{FF2B5EF4-FFF2-40B4-BE49-F238E27FC236}">
              <a16:creationId xmlns:a16="http://schemas.microsoft.com/office/drawing/2014/main" id="{2E161E1E-11FF-FAA0-6883-332079FF80F5}"/>
            </a:ext>
          </a:extLst>
        </cdr:cNvPr>
        <cdr:cNvSpPr txBox="1"/>
      </cdr:nvSpPr>
      <cdr:spPr>
        <a:xfrm xmlns:a="http://schemas.openxmlformats.org/drawingml/2006/main">
          <a:off x="1178663" y="1270787"/>
          <a:ext cx="638619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&lt;0.0001</a:t>
          </a:r>
        </a:p>
      </cdr:txBody>
    </cdr:sp>
  </cdr:relSizeAnchor>
  <cdr:relSizeAnchor xmlns:cdr="http://schemas.openxmlformats.org/drawingml/2006/chartDrawing">
    <cdr:from>
      <cdr:x>0.17162</cdr:x>
      <cdr:y>0.39122</cdr:y>
    </cdr:from>
    <cdr:to>
      <cdr:x>0.2377</cdr:x>
      <cdr:y>0.43661</cdr:y>
    </cdr:to>
    <cdr:sp macro="" textlink="">
      <cdr:nvSpPr>
        <cdr:cNvPr id="25" name="TextBox 46">
          <a:extLst xmlns:a="http://schemas.openxmlformats.org/drawingml/2006/main">
            <a:ext uri="{FF2B5EF4-FFF2-40B4-BE49-F238E27FC236}">
              <a16:creationId xmlns:a16="http://schemas.microsoft.com/office/drawing/2014/main" id="{49D03BAD-67E3-0EF4-62B7-8FD60559498D}"/>
            </a:ext>
          </a:extLst>
        </cdr:cNvPr>
        <cdr:cNvSpPr txBox="1"/>
      </cdr:nvSpPr>
      <cdr:spPr>
        <a:xfrm xmlns:a="http://schemas.openxmlformats.org/drawingml/2006/main">
          <a:off x="1658588" y="1856774"/>
          <a:ext cx="638619" cy="21542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/>
            <a:t>0.2636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CAFF98E-6FE4-8A6B-EA31-C376CF76A4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6FD724F-67F0-864F-23FE-B9A7670A3F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E5063A-2EA8-F745-875B-6279F2E8C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DC84FD7-9144-AB7E-E7CE-BAB0DEEE5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C5F871-5A0C-8B99-1E38-B4E8F2DD3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106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84B07E-BD86-0A25-2F58-06FB8F2BC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6860F6A-F749-A17E-5CE5-3FFAF73F22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EE34A72-B71E-8746-7D11-FC79DE64B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892E3F-2C5D-493A-0CF5-44E553B19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CB5F26-393D-D9E8-F34C-ED25AC9CA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7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DA6DD68-B96F-FC9C-E0F4-F6DD7C27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95189FA-DF9F-EDDD-3A9A-3BDCF76ACD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C093B26-DFE6-2B72-5351-D435DC1A5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9B5B43-E6FC-EB66-6E90-06200F747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F59A0A0-49B5-D33A-6A64-864AEF443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609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F3C241-C92D-19EE-8E3F-02186E09F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2918338-C34D-5FFE-B224-8616BF8833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FE0F68-1518-22CB-F231-C587FF277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39C853-1115-D9FA-1AC5-C49D04036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E57231-8A97-25E4-2135-B0AEA9B53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18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A90A42-08EE-C01B-6B2F-411016DE94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69C4D3A-A0F8-2809-C10E-CD1C316960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BCF195-882E-8EB4-E75F-6616910E4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DA85E2F-4B18-C931-4E8B-804FE9EE5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7C55A03-1BF0-04CA-7C5E-AF4241B18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832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C6DB02-B433-ECBC-1CD6-BE23FA9B6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DD77BEF-4CEC-F600-F72F-D93DB38CC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677D41C-37A6-098C-3DE8-9F0B74D023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18B1376-0662-9E77-2EA9-05FB32C31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B441D27-072A-B5C8-F576-4F85A52A0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46F66D-9311-34F4-5D50-CC65ECCB6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969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445FD0-FDD2-75F3-44A5-4CF3F709F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1E3F3B3-75AE-0F8D-0534-4DD2AF72F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5B58AF5-4747-07FD-02CA-F9F129C41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C619A70-7F9E-67B7-4209-F50E3C80FC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55FDBC6-52C5-B2E4-D8A5-BF1A03ECE0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55909CC-3507-28DB-F475-63F4BA0F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60E6955-99CC-2997-59E3-A6D2F218E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411E164-B298-541A-6387-E7FE562CB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034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FD11C7-DB85-EE21-298B-FBD06B3DD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79AB6AB-28F7-C67C-5E76-4B2FB676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7C085FF-21F8-41B4-06FF-E4F9B1782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F4DBC42-71FE-EF08-93DA-1A143CEF6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150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230A71A-0D9E-4F5D-0EC7-FDFF433A4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A19C190-1ADD-339F-B6A3-54DC04F15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64520EC-B4F6-D2CC-93B7-E247F57F1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32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1734FEB-5082-BA0A-3DC7-318221F0B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4528679-19C7-4D8E-7AAB-0F47A3C7C0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47FD205-4382-4BBC-CAAD-2768DD1227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7EC62B1-3825-1203-C953-FC810F4BC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06F594A-4BE1-6B05-6BDF-ED1BAA917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88F1583-FF16-9880-309C-0018ED287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60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158CFF1-B793-D667-721F-39EBCD3C75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1627BBD0-A8BF-3966-D074-177B8CA2DA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38E6B2D-780A-83ED-2FFA-82FE5CF729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B7C553-BFDF-CBEB-C0DB-E419EC86A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7B4F65A-55F9-953B-30B3-36A1EB347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9A574F1-4020-D41A-264F-56432E5E0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33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BF7F042-5628-3591-12EF-1A73F28C1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3F87C8-D264-312A-6F2E-FBB5EB4A92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B9C0DC0-8754-1207-5F6B-C9494459BF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103F638-C22B-F7D4-C357-D111A6DDE6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8D52924-6057-F103-54F7-DA0AE36A3A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275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AB880B67-FB0B-2CD6-64D1-40D8C9566384}"/>
              </a:ext>
            </a:extLst>
          </p:cNvPr>
          <p:cNvCxnSpPr/>
          <p:nvPr/>
        </p:nvCxnSpPr>
        <p:spPr>
          <a:xfrm>
            <a:off x="8477250" y="2508825"/>
            <a:ext cx="1149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내용 개체 틀 6">
            <a:extLst>
              <a:ext uri="{FF2B5EF4-FFF2-40B4-BE49-F238E27FC236}">
                <a16:creationId xmlns:a16="http://schemas.microsoft.com/office/drawing/2014/main" id="{5F1405D5-3193-496C-68EA-8F9A5FEBC0A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05980017"/>
              </p:ext>
            </p:extLst>
          </p:nvPr>
        </p:nvGraphicFramePr>
        <p:xfrm>
          <a:off x="1263831" y="914400"/>
          <a:ext cx="9664337" cy="47461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7EE0A87-201E-3206-857C-E8A0533DB189}"/>
              </a:ext>
            </a:extLst>
          </p:cNvPr>
          <p:cNvSpPr txBox="1"/>
          <p:nvPr/>
        </p:nvSpPr>
        <p:spPr>
          <a:xfrm>
            <a:off x="3031428" y="5862172"/>
            <a:ext cx="75105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Figure 3. Achievement of target LDL cholesterol goal at 8 week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E67749-6FA7-096E-DA49-5F26BB40DA36}"/>
              </a:ext>
            </a:extLst>
          </p:cNvPr>
          <p:cNvSpPr txBox="1"/>
          <p:nvPr/>
        </p:nvSpPr>
        <p:spPr>
          <a:xfrm rot="10800000" flipH="1">
            <a:off x="682132" y="2066625"/>
            <a:ext cx="430887" cy="196556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600" dirty="0"/>
              <a:t> Achievement Rate %</a:t>
            </a: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DC9BDEEC-13B3-AED4-55C3-6A402D1E4AB5}"/>
              </a:ext>
            </a:extLst>
          </p:cNvPr>
          <p:cNvCxnSpPr>
            <a:cxnSpLocks/>
          </p:cNvCxnSpPr>
          <p:nvPr/>
        </p:nvCxnSpPr>
        <p:spPr>
          <a:xfrm flipV="1">
            <a:off x="2255520" y="1906041"/>
            <a:ext cx="0" cy="7500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23FCBBC0-9BD5-0582-2E81-AD77F53DA2BA}"/>
              </a:ext>
            </a:extLst>
          </p:cNvPr>
          <p:cNvCxnSpPr>
            <a:cxnSpLocks/>
          </p:cNvCxnSpPr>
          <p:nvPr/>
        </p:nvCxnSpPr>
        <p:spPr>
          <a:xfrm>
            <a:off x="2255520" y="1906041"/>
            <a:ext cx="1688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DB93F219-3D9C-8C43-7357-DC7ADC041286}"/>
              </a:ext>
            </a:extLst>
          </p:cNvPr>
          <p:cNvCxnSpPr>
            <a:cxnSpLocks/>
          </p:cNvCxnSpPr>
          <p:nvPr/>
        </p:nvCxnSpPr>
        <p:spPr>
          <a:xfrm>
            <a:off x="3943847" y="1906041"/>
            <a:ext cx="0" cy="18628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AF33EC7E-1F38-AFA8-A5D9-076306165C01}"/>
              </a:ext>
            </a:extLst>
          </p:cNvPr>
          <p:cNvCxnSpPr>
            <a:cxnSpLocks/>
          </p:cNvCxnSpPr>
          <p:nvPr/>
        </p:nvCxnSpPr>
        <p:spPr>
          <a:xfrm flipV="1">
            <a:off x="2393343" y="2146852"/>
            <a:ext cx="0" cy="5092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9C5BB6FC-318B-548B-FA09-2FBF18685CD3}"/>
              </a:ext>
            </a:extLst>
          </p:cNvPr>
          <p:cNvCxnSpPr>
            <a:cxnSpLocks/>
          </p:cNvCxnSpPr>
          <p:nvPr/>
        </p:nvCxnSpPr>
        <p:spPr>
          <a:xfrm>
            <a:off x="2393343" y="2146852"/>
            <a:ext cx="1089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887A7F7A-A72C-1343-E23F-0FBC00E8971F}"/>
              </a:ext>
            </a:extLst>
          </p:cNvPr>
          <p:cNvCxnSpPr>
            <a:cxnSpLocks/>
          </p:cNvCxnSpPr>
          <p:nvPr/>
        </p:nvCxnSpPr>
        <p:spPr>
          <a:xfrm>
            <a:off x="3482671" y="2146852"/>
            <a:ext cx="0" cy="17015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D6751865-8E1A-D502-7712-21FB435F8D0A}"/>
              </a:ext>
            </a:extLst>
          </p:cNvPr>
          <p:cNvCxnSpPr/>
          <p:nvPr/>
        </p:nvCxnSpPr>
        <p:spPr>
          <a:xfrm flipV="1">
            <a:off x="2520563" y="2361537"/>
            <a:ext cx="0" cy="2945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FC119E36-DDB0-E119-FC5C-7BF18CBCE532}"/>
              </a:ext>
            </a:extLst>
          </p:cNvPr>
          <p:cNvCxnSpPr/>
          <p:nvPr/>
        </p:nvCxnSpPr>
        <p:spPr>
          <a:xfrm>
            <a:off x="2520563" y="2361537"/>
            <a:ext cx="2941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83629925-A230-3881-B64A-7243A8A25574}"/>
              </a:ext>
            </a:extLst>
          </p:cNvPr>
          <p:cNvCxnSpPr/>
          <p:nvPr/>
        </p:nvCxnSpPr>
        <p:spPr>
          <a:xfrm>
            <a:off x="2814762" y="2361537"/>
            <a:ext cx="0" cy="1486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FCF60E70-5CFD-F09C-4FB8-B5441D7155F9}"/>
              </a:ext>
            </a:extLst>
          </p:cNvPr>
          <p:cNvCxnSpPr/>
          <p:nvPr/>
        </p:nvCxnSpPr>
        <p:spPr>
          <a:xfrm flipV="1">
            <a:off x="2957885" y="2941983"/>
            <a:ext cx="0" cy="9064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34B0C41F-AE5E-DBBE-D48B-6B148261898E}"/>
              </a:ext>
            </a:extLst>
          </p:cNvPr>
          <p:cNvCxnSpPr>
            <a:cxnSpLocks/>
          </p:cNvCxnSpPr>
          <p:nvPr/>
        </p:nvCxnSpPr>
        <p:spPr>
          <a:xfrm>
            <a:off x="2957885" y="2941983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00C70B34-A853-DA08-58CE-D111912BC108}"/>
              </a:ext>
            </a:extLst>
          </p:cNvPr>
          <p:cNvCxnSpPr>
            <a:cxnSpLocks/>
          </p:cNvCxnSpPr>
          <p:nvPr/>
        </p:nvCxnSpPr>
        <p:spPr>
          <a:xfrm>
            <a:off x="3323645" y="2941983"/>
            <a:ext cx="0" cy="9064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E00D8BAD-6C62-E84D-C1B0-34B38BFC9547}"/>
              </a:ext>
            </a:extLst>
          </p:cNvPr>
          <p:cNvCxnSpPr>
            <a:cxnSpLocks/>
          </p:cNvCxnSpPr>
          <p:nvPr/>
        </p:nvCxnSpPr>
        <p:spPr>
          <a:xfrm>
            <a:off x="5311471" y="1200647"/>
            <a:ext cx="0" cy="540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5352FE5C-F0DA-2934-4408-8A937A9E4EA8}"/>
              </a:ext>
            </a:extLst>
          </p:cNvPr>
          <p:cNvCxnSpPr/>
          <p:nvPr/>
        </p:nvCxnSpPr>
        <p:spPr>
          <a:xfrm>
            <a:off x="5311471" y="1200647"/>
            <a:ext cx="16379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3A24CDEC-E2F7-0E98-EC5B-533B56D609B4}"/>
              </a:ext>
            </a:extLst>
          </p:cNvPr>
          <p:cNvCxnSpPr>
            <a:cxnSpLocks/>
          </p:cNvCxnSpPr>
          <p:nvPr/>
        </p:nvCxnSpPr>
        <p:spPr>
          <a:xfrm>
            <a:off x="6949439" y="1200647"/>
            <a:ext cx="0" cy="2493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1F9DA26C-85E5-FCC2-778A-EF599A18F259}"/>
              </a:ext>
            </a:extLst>
          </p:cNvPr>
          <p:cNvCxnSpPr/>
          <p:nvPr/>
        </p:nvCxnSpPr>
        <p:spPr>
          <a:xfrm>
            <a:off x="5454595" y="1383527"/>
            <a:ext cx="0" cy="3578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ACF7673C-B5D6-F39F-3FEB-0289D9861B28}"/>
              </a:ext>
            </a:extLst>
          </p:cNvPr>
          <p:cNvCxnSpPr/>
          <p:nvPr/>
        </p:nvCxnSpPr>
        <p:spPr>
          <a:xfrm>
            <a:off x="5454595" y="1383527"/>
            <a:ext cx="1073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3328149C-2874-3FC5-7F47-225B7B08008C}"/>
              </a:ext>
            </a:extLst>
          </p:cNvPr>
          <p:cNvCxnSpPr>
            <a:cxnSpLocks/>
          </p:cNvCxnSpPr>
          <p:nvPr/>
        </p:nvCxnSpPr>
        <p:spPr>
          <a:xfrm>
            <a:off x="6528021" y="1383527"/>
            <a:ext cx="0" cy="23109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ADDD785D-485C-ED25-DCC3-189B77673E71}"/>
              </a:ext>
            </a:extLst>
          </p:cNvPr>
          <p:cNvCxnSpPr>
            <a:cxnSpLocks/>
          </p:cNvCxnSpPr>
          <p:nvPr/>
        </p:nvCxnSpPr>
        <p:spPr>
          <a:xfrm>
            <a:off x="5592169" y="1562431"/>
            <a:ext cx="2721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845E6C44-7C17-A281-3F11-B77DFC30F477}"/>
              </a:ext>
            </a:extLst>
          </p:cNvPr>
          <p:cNvCxnSpPr/>
          <p:nvPr/>
        </p:nvCxnSpPr>
        <p:spPr>
          <a:xfrm flipV="1">
            <a:off x="5991308" y="2986603"/>
            <a:ext cx="0" cy="7078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AC57BEDB-1BE9-09D7-25E9-26E9483D302B}"/>
              </a:ext>
            </a:extLst>
          </p:cNvPr>
          <p:cNvCxnSpPr/>
          <p:nvPr/>
        </p:nvCxnSpPr>
        <p:spPr>
          <a:xfrm>
            <a:off x="5991308" y="2986603"/>
            <a:ext cx="3726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2A52440C-B419-391D-503E-29FF8C3E44AB}"/>
              </a:ext>
            </a:extLst>
          </p:cNvPr>
          <p:cNvCxnSpPr>
            <a:cxnSpLocks/>
          </p:cNvCxnSpPr>
          <p:nvPr/>
        </p:nvCxnSpPr>
        <p:spPr>
          <a:xfrm>
            <a:off x="6363929" y="2986603"/>
            <a:ext cx="0" cy="7078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BB1433E3-E485-7B8A-1F48-7B4C7A59AC8C}"/>
              </a:ext>
            </a:extLst>
          </p:cNvPr>
          <p:cNvCxnSpPr/>
          <p:nvPr/>
        </p:nvCxnSpPr>
        <p:spPr>
          <a:xfrm>
            <a:off x="8362335" y="2327743"/>
            <a:ext cx="0" cy="5851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1BE4CC1A-5651-BB95-8B50-A2825716BE41}"/>
              </a:ext>
            </a:extLst>
          </p:cNvPr>
          <p:cNvCxnSpPr>
            <a:cxnSpLocks/>
          </p:cNvCxnSpPr>
          <p:nvPr/>
        </p:nvCxnSpPr>
        <p:spPr>
          <a:xfrm>
            <a:off x="8362335" y="2327743"/>
            <a:ext cx="16643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09F758BB-C9F8-045A-DE13-3B53A6574DBF}"/>
              </a:ext>
            </a:extLst>
          </p:cNvPr>
          <p:cNvCxnSpPr/>
          <p:nvPr/>
        </p:nvCxnSpPr>
        <p:spPr>
          <a:xfrm>
            <a:off x="10026650" y="2327743"/>
            <a:ext cx="0" cy="18950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DA1FDE65-61E8-3BC5-D538-BFF4D1B63D19}"/>
              </a:ext>
            </a:extLst>
          </p:cNvPr>
          <p:cNvCxnSpPr>
            <a:cxnSpLocks/>
          </p:cNvCxnSpPr>
          <p:nvPr/>
        </p:nvCxnSpPr>
        <p:spPr>
          <a:xfrm>
            <a:off x="8477250" y="2508825"/>
            <a:ext cx="0" cy="4040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0F22D88E-E957-A89B-80D4-36BADD7B1135}"/>
              </a:ext>
            </a:extLst>
          </p:cNvPr>
          <p:cNvCxnSpPr>
            <a:cxnSpLocks/>
          </p:cNvCxnSpPr>
          <p:nvPr/>
        </p:nvCxnSpPr>
        <p:spPr>
          <a:xfrm>
            <a:off x="9626600" y="2508825"/>
            <a:ext cx="0" cy="16047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003FCEF4-AB3A-9678-B786-5DDF31B233D2}"/>
              </a:ext>
            </a:extLst>
          </p:cNvPr>
          <p:cNvCxnSpPr>
            <a:cxnSpLocks/>
          </p:cNvCxnSpPr>
          <p:nvPr/>
        </p:nvCxnSpPr>
        <p:spPr>
          <a:xfrm>
            <a:off x="8604250" y="2675164"/>
            <a:ext cx="0" cy="2376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962CD799-3866-CE8A-5FEB-41DB54573FCA}"/>
              </a:ext>
            </a:extLst>
          </p:cNvPr>
          <p:cNvCxnSpPr>
            <a:cxnSpLocks/>
          </p:cNvCxnSpPr>
          <p:nvPr/>
        </p:nvCxnSpPr>
        <p:spPr>
          <a:xfrm>
            <a:off x="8604250" y="2675164"/>
            <a:ext cx="342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109D51C2-1711-298D-5B58-B844295FE88C}"/>
              </a:ext>
            </a:extLst>
          </p:cNvPr>
          <p:cNvCxnSpPr/>
          <p:nvPr/>
        </p:nvCxnSpPr>
        <p:spPr>
          <a:xfrm>
            <a:off x="8947150" y="2675164"/>
            <a:ext cx="0" cy="14436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id="{F3D533E0-58E5-5B2E-D043-5E18739D8099}"/>
              </a:ext>
            </a:extLst>
          </p:cNvPr>
          <p:cNvCxnSpPr/>
          <p:nvPr/>
        </p:nvCxnSpPr>
        <p:spPr>
          <a:xfrm>
            <a:off x="9051925" y="3395207"/>
            <a:ext cx="0" cy="7183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>
            <a:extLst>
              <a:ext uri="{FF2B5EF4-FFF2-40B4-BE49-F238E27FC236}">
                <a16:creationId xmlns:a16="http://schemas.microsoft.com/office/drawing/2014/main" id="{C54708B9-3611-D6B5-504C-C14E5423F8AE}"/>
              </a:ext>
            </a:extLst>
          </p:cNvPr>
          <p:cNvCxnSpPr/>
          <p:nvPr/>
        </p:nvCxnSpPr>
        <p:spPr>
          <a:xfrm>
            <a:off x="9058402" y="3395207"/>
            <a:ext cx="384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4730DA25-12DD-9851-E552-A14354BE4278}"/>
              </a:ext>
            </a:extLst>
          </p:cNvPr>
          <p:cNvCxnSpPr>
            <a:cxnSpLocks/>
          </p:cNvCxnSpPr>
          <p:nvPr/>
        </p:nvCxnSpPr>
        <p:spPr>
          <a:xfrm>
            <a:off x="9442450" y="3395207"/>
            <a:ext cx="0" cy="7183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54352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8</TotalTime>
  <Words>33</Words>
  <Application>Microsoft Office PowerPoint</Application>
  <PresentationFormat>와이드스크린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정은(ADDP)</dc:creator>
  <cp:lastModifiedBy>Windows User</cp:lastModifiedBy>
  <cp:revision>43</cp:revision>
  <dcterms:created xsi:type="dcterms:W3CDTF">2022-07-21T23:45:26Z</dcterms:created>
  <dcterms:modified xsi:type="dcterms:W3CDTF">2023-09-30T21:50:33Z</dcterms:modified>
</cp:coreProperties>
</file>